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1FF"/>
    <a:srgbClr val="01FDFF"/>
    <a:srgbClr val="03FBA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620"/>
    <p:restoredTop sz="94690"/>
  </p:normalViewPr>
  <p:slideViewPr>
    <p:cSldViewPr snapToGrid="0" snapToObjects="1">
      <p:cViewPr varScale="1">
        <p:scale>
          <a:sx n="59" d="100"/>
          <a:sy n="59" d="100"/>
        </p:scale>
        <p:origin x="216" y="8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D35BC7-1E24-7A41-AC4A-D47C3B9E47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ADB662F-92FE-3349-A4DC-37BB496F53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9E1232-1D86-8E4F-94F7-560EB8A1C8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D00F-08DA-7349-8C10-AA804CF2EBA7}" type="datetimeFigureOut">
              <a:rPr lang="en-US" smtClean="0"/>
              <a:t>3/1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69C234-7BB8-5949-A63F-0AC64473E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54E0BF-6853-1F49-9627-A8705F7F5A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9A361-DBE6-EB46-9BFC-9BC55D7E6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630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8244B9-6221-C64F-9E35-E412C2C744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F69679-FA7E-7444-8D35-B2ACE9D425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64DCD5-4D89-6D49-9F8F-C7996C3987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D00F-08DA-7349-8C10-AA804CF2EBA7}" type="datetimeFigureOut">
              <a:rPr lang="en-US" smtClean="0"/>
              <a:t>3/1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C3C463-4FEB-474D-B8BD-CABEF16C26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981BCF-0741-A945-BAB4-2C93F77A2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9A361-DBE6-EB46-9BFC-9BC55D7E6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640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B00DE8D-3382-9446-BCA3-3FE731079A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1BDB8C-8178-4F47-A96F-09BDCBCC62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AB2526-3838-8640-B6C3-CCA8CE11F3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D00F-08DA-7349-8C10-AA804CF2EBA7}" type="datetimeFigureOut">
              <a:rPr lang="en-US" smtClean="0"/>
              <a:t>3/1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BD0C0B-A086-DB41-89D7-EC5693492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364BFB-B2C4-6C4D-9E9C-51226BF07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9A361-DBE6-EB46-9BFC-9BC55D7E6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4702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83EB3-B33C-8A4A-9410-C21E9A7FB4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BAEEB3-A3BB-3942-95BB-C87959EB17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3C9DE5-CE7E-A548-91D6-2FF41FC77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D00F-08DA-7349-8C10-AA804CF2EBA7}" type="datetimeFigureOut">
              <a:rPr lang="en-US" smtClean="0"/>
              <a:t>3/1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58AD3A-EE7B-DA4D-A3E8-30CEC2B0A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0A65EC-AF56-B848-8325-4EB4734EB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9A361-DBE6-EB46-9BFC-9BC55D7E6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419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02B3B6-AA33-8D40-A1FC-F89A2A12E6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FF5137-2EA4-9A42-8040-310304469E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225D04-8BEA-944C-A506-F9CF7CFB46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D00F-08DA-7349-8C10-AA804CF2EBA7}" type="datetimeFigureOut">
              <a:rPr lang="en-US" smtClean="0"/>
              <a:t>3/1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BCB467-F568-8043-BE3C-78E04B01FA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ADD401-C267-6644-BECF-3165636C54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9A361-DBE6-EB46-9BFC-9BC55D7E6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4630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246B6B-0767-7443-8EDB-37A149C249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C9F584-33D3-F84B-AAD3-9C3A80E9C2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B4A8E7-56F9-5246-9EE0-BEB9A3A818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CAE202-BF2F-9041-A207-674524A432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D00F-08DA-7349-8C10-AA804CF2EBA7}" type="datetimeFigureOut">
              <a:rPr lang="en-US" smtClean="0"/>
              <a:t>3/19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1410E0-FB9A-D140-8C3E-C61A0A7CB7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1599C1-02F9-6442-8EC8-8FCD7E3D8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9A361-DBE6-EB46-9BFC-9BC55D7E6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718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64E1B0-6ADB-EA46-B7A9-2A29EBCDEF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6E4495-8795-6247-AD68-6121F809B0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8C7994-A711-E249-B4DA-0DEFE849E7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6B407AF-14C3-D949-BFB4-7CDE62D35A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528BF90-5962-BE4F-B1AE-1BC1C84CF7E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85968E-0876-F44B-9FF0-BAD2DC829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D00F-08DA-7349-8C10-AA804CF2EBA7}" type="datetimeFigureOut">
              <a:rPr lang="en-US" smtClean="0"/>
              <a:t>3/19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2D56294-33C9-004C-85D1-9668989C79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E9CE16E-9BC3-8941-B4A8-723301BC0E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9A361-DBE6-EB46-9BFC-9BC55D7E6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086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DE7FBE-344C-8F43-A908-83F840457E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387CA58-1678-2A4A-80B0-9E8027F614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D00F-08DA-7349-8C10-AA804CF2EBA7}" type="datetimeFigureOut">
              <a:rPr lang="en-US" smtClean="0"/>
              <a:t>3/19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E041975-DDAA-E64B-90D6-58105A232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97AE05F-3E8B-8140-B952-829016728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9A361-DBE6-EB46-9BFC-9BC55D7E6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732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A36421A-774C-2A4E-86C6-D5BB422880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D00F-08DA-7349-8C10-AA804CF2EBA7}" type="datetimeFigureOut">
              <a:rPr lang="en-US" smtClean="0"/>
              <a:t>3/19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CDA0281-77D9-7448-938A-E2AA5B731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011F9C7-781C-974A-9CED-3A797E2D23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9A361-DBE6-EB46-9BFC-9BC55D7E6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747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BDA6AC-024C-4D49-A72C-55E90C6E37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E9860B-C7AA-014A-8A2B-875FE87C15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EF6C7C-94E3-9D4B-A2F7-D84F0F4B3B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45BDDD-30F7-0848-8402-D342ECAFF4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D00F-08DA-7349-8C10-AA804CF2EBA7}" type="datetimeFigureOut">
              <a:rPr lang="en-US" smtClean="0"/>
              <a:t>3/19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0B1896-C869-B145-BAEF-ACB802AEF8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6B455C-863B-3B41-8E73-A8D9D4EB32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9A361-DBE6-EB46-9BFC-9BC55D7E6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435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32041C-D676-3B4C-BF15-71891DC200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01E533-1D56-6343-9151-7A0B43D04E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3C4E98-5850-3044-BCA6-9D909FE6F4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29D724-B295-F644-BBBA-0C9D859908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D00F-08DA-7349-8C10-AA804CF2EBA7}" type="datetimeFigureOut">
              <a:rPr lang="en-US" smtClean="0"/>
              <a:t>3/19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9A5015-6B14-D247-AEED-26561741EA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7E0600-A80D-9B4A-85DD-DC686A55E2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9A361-DBE6-EB46-9BFC-9BC55D7E6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09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7F1935B-4AAB-5047-9807-F6342C8AA4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B26AAB-D923-5C48-968D-9C4906F2AD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BB8956-959C-744C-92BD-46FA252F4E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50D00F-08DA-7349-8C10-AA804CF2EBA7}" type="datetimeFigureOut">
              <a:rPr lang="en-US" smtClean="0"/>
              <a:t>3/1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C20865-643B-DA42-BEEE-19E12B8C032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B3C477-7F4F-324D-8400-41374E6A09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9A361-DBE6-EB46-9BFC-9BC55D7E6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528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D89EC4D-DB1F-EF49-AE84-33DC1205AF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3530" y="293956"/>
            <a:ext cx="4635500" cy="27813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ABCCCF1-C91A-F04B-9D60-0CA1EE87DF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3530" y="3571729"/>
            <a:ext cx="4635500" cy="27813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02EB16A-9414-FE47-8055-B8FAD4AAAA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26361" y="293956"/>
            <a:ext cx="4635500" cy="27813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DA59AC91-DEF9-774A-A0D6-E84D419F7E6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26361" y="3571729"/>
            <a:ext cx="4635500" cy="278130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F4F7B779-4A5A-D243-81D3-A2C8ABC239F0}"/>
              </a:ext>
            </a:extLst>
          </p:cNvPr>
          <p:cNvSpPr txBox="1"/>
          <p:nvPr/>
        </p:nvSpPr>
        <p:spPr>
          <a:xfrm>
            <a:off x="3390314" y="3075256"/>
            <a:ext cx="14349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sterase (Est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4EE8697-0F57-324F-87D1-BDE4593E6F55}"/>
              </a:ext>
            </a:extLst>
          </p:cNvPr>
          <p:cNvSpPr txBox="1"/>
          <p:nvPr/>
        </p:nvSpPr>
        <p:spPr>
          <a:xfrm>
            <a:off x="3363445" y="6353029"/>
            <a:ext cx="1574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ET Hydrolas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9EA23B4-50BC-8C43-AEE5-609BEA2E884D}"/>
              </a:ext>
            </a:extLst>
          </p:cNvPr>
          <p:cNvSpPr txBox="1"/>
          <p:nvPr/>
        </p:nvSpPr>
        <p:spPr>
          <a:xfrm>
            <a:off x="9340948" y="3075256"/>
            <a:ext cx="2406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erine Esterase (</a:t>
            </a:r>
            <a:r>
              <a:rPr lang="en-US" dirty="0" err="1"/>
              <a:t>SerEst</a:t>
            </a:r>
            <a:r>
              <a:rPr lang="en-US" dirty="0"/>
              <a:t>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35DC747-796D-934E-B1AA-58A17E52338F}"/>
              </a:ext>
            </a:extLst>
          </p:cNvPr>
          <p:cNvSpPr txBox="1"/>
          <p:nvPr/>
        </p:nvSpPr>
        <p:spPr>
          <a:xfrm>
            <a:off x="10723196" y="6353029"/>
            <a:ext cx="102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ll genes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25145928-C484-3143-B6FA-B8F6609512C4}"/>
              </a:ext>
            </a:extLst>
          </p:cNvPr>
          <p:cNvGrpSpPr/>
          <p:nvPr/>
        </p:nvGrpSpPr>
        <p:grpSpPr>
          <a:xfrm>
            <a:off x="5051272" y="4438570"/>
            <a:ext cx="1962847" cy="1047618"/>
            <a:chOff x="5051272" y="783858"/>
            <a:chExt cx="1962847" cy="1047618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7FC5CF6-609E-3548-9549-6B880052C9ED}"/>
                </a:ext>
              </a:extLst>
            </p:cNvPr>
            <p:cNvSpPr txBox="1"/>
            <p:nvPr/>
          </p:nvSpPr>
          <p:spPr>
            <a:xfrm>
              <a:off x="5051272" y="1523699"/>
              <a:ext cx="19355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/>
                <a:t>Micropolyethylene</a:t>
              </a:r>
              <a:endParaRPr lang="en-US" sz="1400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253EAE6-249C-E84D-ABA3-D658159EC1E4}"/>
                </a:ext>
              </a:extLst>
            </p:cNvPr>
            <p:cNvSpPr txBox="1"/>
            <p:nvPr/>
          </p:nvSpPr>
          <p:spPr>
            <a:xfrm>
              <a:off x="5546627" y="793517"/>
              <a:ext cx="14349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Control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89977EA-7665-BD44-9FBD-A2DBF39FC96F}"/>
                </a:ext>
              </a:extLst>
            </p:cNvPr>
            <p:cNvSpPr txBox="1"/>
            <p:nvPr/>
          </p:nvSpPr>
          <p:spPr>
            <a:xfrm>
              <a:off x="5078540" y="1144410"/>
              <a:ext cx="19355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/>
                <a:t>Nanopolyethylene</a:t>
              </a:r>
              <a:endParaRPr lang="en-US" sz="1400" dirty="0"/>
            </a:p>
          </p:txBody>
        </p:sp>
        <p:sp>
          <p:nvSpPr>
            <p:cNvPr id="25" name="Rounded Rectangle 24">
              <a:extLst>
                <a:ext uri="{FF2B5EF4-FFF2-40B4-BE49-F238E27FC236}">
                  <a16:creationId xmlns:a16="http://schemas.microsoft.com/office/drawing/2014/main" id="{3E63DA78-CAAA-BA4E-8B2B-4760B257C348}"/>
                </a:ext>
              </a:extLst>
            </p:cNvPr>
            <p:cNvSpPr/>
            <p:nvPr/>
          </p:nvSpPr>
          <p:spPr>
            <a:xfrm>
              <a:off x="6585825" y="783858"/>
              <a:ext cx="280852" cy="274320"/>
            </a:xfrm>
            <a:prstGeom prst="roundRect">
              <a:avLst/>
            </a:prstGeom>
            <a:solidFill>
              <a:srgbClr val="03FBA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6" name="Rounded Rectangle 25">
              <a:extLst>
                <a:ext uri="{FF2B5EF4-FFF2-40B4-BE49-F238E27FC236}">
                  <a16:creationId xmlns:a16="http://schemas.microsoft.com/office/drawing/2014/main" id="{3E8E71DC-8148-9E4D-A88C-8A719D9B0AF1}"/>
                </a:ext>
              </a:extLst>
            </p:cNvPr>
            <p:cNvSpPr/>
            <p:nvPr/>
          </p:nvSpPr>
          <p:spPr>
            <a:xfrm>
              <a:off x="6585824" y="1164654"/>
              <a:ext cx="283464" cy="274320"/>
            </a:xfrm>
            <a:prstGeom prst="roundRect">
              <a:avLst/>
            </a:prstGeom>
            <a:solidFill>
              <a:srgbClr val="01FDFF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7" name="Rounded Rectangle 26">
              <a:extLst>
                <a:ext uri="{FF2B5EF4-FFF2-40B4-BE49-F238E27FC236}">
                  <a16:creationId xmlns:a16="http://schemas.microsoft.com/office/drawing/2014/main" id="{5F0BC10B-DCDC-6744-87F4-7B09D85AE937}"/>
                </a:ext>
              </a:extLst>
            </p:cNvPr>
            <p:cNvSpPr/>
            <p:nvPr/>
          </p:nvSpPr>
          <p:spPr>
            <a:xfrm>
              <a:off x="6585825" y="1557156"/>
              <a:ext cx="283464" cy="274320"/>
            </a:xfrm>
            <a:prstGeom prst="roundRect">
              <a:avLst/>
            </a:prstGeom>
            <a:solidFill>
              <a:srgbClr val="0081FF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50C29E6E-855C-4242-931C-57E8546FA763}"/>
              </a:ext>
            </a:extLst>
          </p:cNvPr>
          <p:cNvGrpSpPr/>
          <p:nvPr/>
        </p:nvGrpSpPr>
        <p:grpSpPr>
          <a:xfrm>
            <a:off x="5078540" y="1095484"/>
            <a:ext cx="1962847" cy="1047618"/>
            <a:chOff x="5051272" y="783858"/>
            <a:chExt cx="1962847" cy="1047618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D8895F3-2D87-A742-83ED-E21925BB9ED7}"/>
                </a:ext>
              </a:extLst>
            </p:cNvPr>
            <p:cNvSpPr txBox="1"/>
            <p:nvPr/>
          </p:nvSpPr>
          <p:spPr>
            <a:xfrm>
              <a:off x="5051272" y="1523699"/>
              <a:ext cx="19355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/>
                <a:t>Micropolyethylene</a:t>
              </a:r>
              <a:endParaRPr lang="en-US" sz="1400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E1DD3C5-B9CE-9B49-BCCD-CCAD9165A3FC}"/>
                </a:ext>
              </a:extLst>
            </p:cNvPr>
            <p:cNvSpPr txBox="1"/>
            <p:nvPr/>
          </p:nvSpPr>
          <p:spPr>
            <a:xfrm>
              <a:off x="5546627" y="793517"/>
              <a:ext cx="14349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Control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68CD27F-FA55-3342-89FF-1A0D45CC3784}"/>
                </a:ext>
              </a:extLst>
            </p:cNvPr>
            <p:cNvSpPr txBox="1"/>
            <p:nvPr/>
          </p:nvSpPr>
          <p:spPr>
            <a:xfrm>
              <a:off x="5078540" y="1144410"/>
              <a:ext cx="19355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/>
                <a:t>Nanopolyethylene</a:t>
              </a:r>
              <a:endParaRPr lang="en-US" sz="1400" dirty="0"/>
            </a:p>
          </p:txBody>
        </p:sp>
        <p:sp>
          <p:nvSpPr>
            <p:cNvPr id="35" name="Rounded Rectangle 34">
              <a:extLst>
                <a:ext uri="{FF2B5EF4-FFF2-40B4-BE49-F238E27FC236}">
                  <a16:creationId xmlns:a16="http://schemas.microsoft.com/office/drawing/2014/main" id="{6FF20005-20A5-C248-9AA8-4309D297EB0D}"/>
                </a:ext>
              </a:extLst>
            </p:cNvPr>
            <p:cNvSpPr/>
            <p:nvPr/>
          </p:nvSpPr>
          <p:spPr>
            <a:xfrm>
              <a:off x="6585825" y="783858"/>
              <a:ext cx="280852" cy="274320"/>
            </a:xfrm>
            <a:prstGeom prst="roundRect">
              <a:avLst/>
            </a:prstGeom>
            <a:solidFill>
              <a:srgbClr val="03FBA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6" name="Rounded Rectangle 35">
              <a:extLst>
                <a:ext uri="{FF2B5EF4-FFF2-40B4-BE49-F238E27FC236}">
                  <a16:creationId xmlns:a16="http://schemas.microsoft.com/office/drawing/2014/main" id="{7D942F24-6060-1F40-A190-6FEEF4BAD743}"/>
                </a:ext>
              </a:extLst>
            </p:cNvPr>
            <p:cNvSpPr/>
            <p:nvPr/>
          </p:nvSpPr>
          <p:spPr>
            <a:xfrm>
              <a:off x="6585824" y="1164654"/>
              <a:ext cx="283464" cy="274320"/>
            </a:xfrm>
            <a:prstGeom prst="roundRect">
              <a:avLst/>
            </a:prstGeom>
            <a:solidFill>
              <a:srgbClr val="01FDFF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7" name="Rounded Rectangle 36">
              <a:extLst>
                <a:ext uri="{FF2B5EF4-FFF2-40B4-BE49-F238E27FC236}">
                  <a16:creationId xmlns:a16="http://schemas.microsoft.com/office/drawing/2014/main" id="{436FB1A2-2F38-FE4F-8BC2-CCD6852B34E2}"/>
                </a:ext>
              </a:extLst>
            </p:cNvPr>
            <p:cNvSpPr/>
            <p:nvPr/>
          </p:nvSpPr>
          <p:spPr>
            <a:xfrm>
              <a:off x="6585825" y="1557156"/>
              <a:ext cx="283464" cy="274320"/>
            </a:xfrm>
            <a:prstGeom prst="roundRect">
              <a:avLst/>
            </a:prstGeom>
            <a:solidFill>
              <a:srgbClr val="0081FF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34231351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19</Words>
  <Application>Microsoft Macintosh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y Machado</dc:creator>
  <cp:lastModifiedBy>Mary Machado</cp:lastModifiedBy>
  <cp:revision>4</cp:revision>
  <dcterms:created xsi:type="dcterms:W3CDTF">2020-03-19T16:27:09Z</dcterms:created>
  <dcterms:modified xsi:type="dcterms:W3CDTF">2020-03-19T17:01:46Z</dcterms:modified>
</cp:coreProperties>
</file>